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572" y="3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LIMA BANGAR" userId="18c4798c2ea7cdef" providerId="LiveId" clId="{B730B79E-1968-49A5-966B-5486AF96D05E}"/>
    <pc:docChg chg="modSld">
      <pc:chgData name="NILIMA BANGAR" userId="18c4798c2ea7cdef" providerId="LiveId" clId="{B730B79E-1968-49A5-966B-5486AF96D05E}" dt="2025-07-17T18:08:05.773" v="19" actId="1076"/>
      <pc:docMkLst>
        <pc:docMk/>
      </pc:docMkLst>
      <pc:sldChg chg="addSp modSp mod">
        <pc:chgData name="NILIMA BANGAR" userId="18c4798c2ea7cdef" providerId="LiveId" clId="{B730B79E-1968-49A5-966B-5486AF96D05E}" dt="2025-07-17T18:08:05.773" v="19" actId="1076"/>
        <pc:sldMkLst>
          <pc:docMk/>
          <pc:sldMk cId="3944487083" sldId="257"/>
        </pc:sldMkLst>
        <pc:spChg chg="add mod">
          <ac:chgData name="NILIMA BANGAR" userId="18c4798c2ea7cdef" providerId="LiveId" clId="{B730B79E-1968-49A5-966B-5486AF96D05E}" dt="2025-07-17T18:07:41.855" v="13" actId="1076"/>
          <ac:spMkLst>
            <pc:docMk/>
            <pc:sldMk cId="3944487083" sldId="257"/>
            <ac:spMk id="5" creationId="{2CBD2D9A-7942-7339-B994-E1982A1EC469}"/>
          </ac:spMkLst>
        </pc:spChg>
        <pc:spChg chg="mod">
          <ac:chgData name="NILIMA BANGAR" userId="18c4798c2ea7cdef" providerId="LiveId" clId="{B730B79E-1968-49A5-966B-5486AF96D05E}" dt="2025-07-17T18:07:01.103" v="2" actId="1076"/>
          <ac:spMkLst>
            <pc:docMk/>
            <pc:sldMk cId="3944487083" sldId="257"/>
            <ac:spMk id="9" creationId="{81376C05-E0F0-A07D-9EB2-61DBE7B476FA}"/>
          </ac:spMkLst>
        </pc:spChg>
        <pc:spChg chg="mod">
          <ac:chgData name="NILIMA BANGAR" userId="18c4798c2ea7cdef" providerId="LiveId" clId="{B730B79E-1968-49A5-966B-5486AF96D05E}" dt="2025-07-17T18:07:05.525" v="3" actId="1076"/>
          <ac:spMkLst>
            <pc:docMk/>
            <pc:sldMk cId="3944487083" sldId="257"/>
            <ac:spMk id="11" creationId="{911E3916-BA77-9F1D-02BD-11DB52075BED}"/>
          </ac:spMkLst>
        </pc:spChg>
        <pc:spChg chg="add mod">
          <ac:chgData name="NILIMA BANGAR" userId="18c4798c2ea7cdef" providerId="LiveId" clId="{B730B79E-1968-49A5-966B-5486AF96D05E}" dt="2025-07-17T18:07:50.615" v="15" actId="1076"/>
          <ac:spMkLst>
            <pc:docMk/>
            <pc:sldMk cId="3944487083" sldId="257"/>
            <ac:spMk id="12" creationId="{7E2A0CC6-DD56-6D6D-AFFB-D83F5D5E06AE}"/>
          </ac:spMkLst>
        </pc:spChg>
        <pc:spChg chg="mod">
          <ac:chgData name="NILIMA BANGAR" userId="18c4798c2ea7cdef" providerId="LiveId" clId="{B730B79E-1968-49A5-966B-5486AF96D05E}" dt="2025-07-17T10:48:06.412" v="1" actId="20577"/>
          <ac:spMkLst>
            <pc:docMk/>
            <pc:sldMk cId="3944487083" sldId="257"/>
            <ac:spMk id="13" creationId="{54D0B0A2-BB66-E356-8223-598FBE4EA5BB}"/>
          </ac:spMkLst>
        </pc:spChg>
        <pc:spChg chg="add mod">
          <ac:chgData name="NILIMA BANGAR" userId="18c4798c2ea7cdef" providerId="LiveId" clId="{B730B79E-1968-49A5-966B-5486AF96D05E}" dt="2025-07-17T18:07:57.256" v="17" actId="1076"/>
          <ac:spMkLst>
            <pc:docMk/>
            <pc:sldMk cId="3944487083" sldId="257"/>
            <ac:spMk id="14" creationId="{9C7B45FE-CEE3-9148-CE19-23B2D496A5C0}"/>
          </ac:spMkLst>
        </pc:spChg>
        <pc:spChg chg="add mod">
          <ac:chgData name="NILIMA BANGAR" userId="18c4798c2ea7cdef" providerId="LiveId" clId="{B730B79E-1968-49A5-966B-5486AF96D05E}" dt="2025-07-17T18:08:05.773" v="19" actId="1076"/>
          <ac:spMkLst>
            <pc:docMk/>
            <pc:sldMk cId="3944487083" sldId="257"/>
            <ac:spMk id="15" creationId="{6ADC0C24-C04C-466B-2335-8D7B5440A233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711B75-35F4-BEEE-544F-A2C6987DF8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258D3F-26A3-45EC-CD19-2A05247C5D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3B1A9E-91C2-C24B-724D-7742F46142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1F48A-2F21-4094-8ECA-474A1CF3030C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25AF6C-7BAF-3570-A87A-3BF87F067B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C27C5-10B9-E521-2F8F-795884F8D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5FE5B-11C9-4174-A0D7-71D6DFD62EF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91711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2C8D77-9852-FD0A-A824-C3EF002573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6B8686-6B8B-2DBC-A89A-5CB121C110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64BA25-32AB-CE59-450C-35F9459A4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1F48A-2F21-4094-8ECA-474A1CF3030C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094D91-6603-9A27-7468-93AD755C88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5E1816-25EE-D468-FD76-8EB60991D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5FE5B-11C9-4174-A0D7-71D6DFD62EF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19363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5BB751A-2215-E2ED-093C-2C3050F0B6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125F72-9D40-173F-FE27-901FF872FD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8B85CC-B8A8-CF34-686D-4A82EBC16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1F48A-2F21-4094-8ECA-474A1CF3030C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3FAC30-B54B-EE3B-1FC7-9FE54D1DFA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B80C15-E1FA-FDDF-C1F0-4FDC85E49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5FE5B-11C9-4174-A0D7-71D6DFD62EF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704053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45C50B-C4B6-63B0-31A7-7C0A051C0C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E9BB92-AAE4-673F-9EFA-83246B866E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009CFB-5347-D3FD-E850-BFDBC41E7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1F48A-2F21-4094-8ECA-474A1CF3030C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AF1D16-A968-8119-0925-05F7863296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5E5379-A9C5-5A85-E221-148BD719B7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5FE5B-11C9-4174-A0D7-71D6DFD62EF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16116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50692A-B74A-980A-E47D-3F37F555B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A5503A-C659-0D50-5934-0ACAC4B070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C8A2A4-3732-E3A9-C0FD-CB5DFB734C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1F48A-2F21-4094-8ECA-474A1CF3030C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83C36A-7EFC-67BC-B412-26A63DAFA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978B5A-94AE-AA7E-F2F6-03372EAEB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5FE5B-11C9-4174-A0D7-71D6DFD62EF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89957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E16AB0-A896-927B-802C-9688FA4122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174D7B-F071-0021-A907-C787EB8ADF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F2BE40-15F8-4396-A1DC-DDC0D278A1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430DC6-C437-6D7C-3769-F88DBB3A46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1F48A-2F21-4094-8ECA-474A1CF3030C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6B0AC6-B1B3-E3C7-50A6-E99F228336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A55591-3989-7FE5-FF98-88879688A1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5FE5B-11C9-4174-A0D7-71D6DFD62EF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84182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F9564D-09BE-6070-08A1-154340CFA6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8F3562-A563-D943-16DA-15EC28F072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6CB5968-BA16-4E00-7889-FCC4B4677A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00257D3-0C9F-D54E-3445-C99FD246D9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7CCC9E4-5DD6-6D0C-6146-15D115D306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A3BAB0C-1C54-FCB3-E799-B259A4EC4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1F48A-2F21-4094-8ECA-474A1CF3030C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FC30C9-AC75-1F57-5E76-CC242790F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077838-C38A-CF5A-C617-68A6BFD21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5FE5B-11C9-4174-A0D7-71D6DFD62EF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14803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5A133E-DC96-238F-09E8-1B95050FFD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7E58B1-6CA7-ADC8-CE4F-8CF1FEFDE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1F48A-2F21-4094-8ECA-474A1CF3030C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20161C-9351-6E0D-FA38-E32784172D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C9CA46C-FD65-3D2C-F4E7-23B747214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5FE5B-11C9-4174-A0D7-71D6DFD62EF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220682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A6A72B7-9CD5-4392-DD7E-54AB86B541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1F48A-2F21-4094-8ECA-474A1CF3030C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FEA67E1-83B4-DE07-DCAF-9B957F8D2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34CE2D-A55A-EBB5-3F27-4D2124D57E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5FE5B-11C9-4174-A0D7-71D6DFD62EF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05502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05C204-51DB-6DCC-870E-CE195D5F68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E2F467-E517-1879-1EE1-1CF4C15014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1FA36F-43C8-B40F-96A2-545FCF5A28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FEA896-F06F-18D3-CA7D-9CB82C606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1F48A-2F21-4094-8ECA-474A1CF3030C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97C731-D60E-6B76-8A07-6BF61FFE9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8F8C85-2D0F-13AD-FB85-71439559A8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5FE5B-11C9-4174-A0D7-71D6DFD62EF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95411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D4DFDA-BA49-AC89-6604-97A17F732D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E403713-CC39-8BEF-9A6E-3CFD052DC8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AFE49A-50E5-B59C-8642-0959BDA2BF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698B09-049A-398C-B3F9-DF672BC618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1F48A-2F21-4094-8ECA-474A1CF3030C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450DDC-F248-CE53-782E-B8A9DC6894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52F3E6-BE8B-BE0B-15E0-EC8259D6D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5FE5B-11C9-4174-A0D7-71D6DFD62EF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34042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40DCD0-BE04-27C6-5D43-1C47E8DF7F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FDD07B-805E-8419-AF79-3A7D6D37C4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3991D4-1859-9D53-EF71-6B3A980F8F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71F48A-2F21-4094-8ECA-474A1CF3030C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DDC79-2B60-1DF7-2C78-0D0904951A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A3D3FA-FBCC-5C2C-604D-6B7F7E8B60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A5FE5B-11C9-4174-A0D7-71D6DFD62EF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44094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8B043C3-6312-B5E4-BA7F-F49CC1F03071}"/>
              </a:ext>
            </a:extLst>
          </p:cNvPr>
          <p:cNvSpPr txBox="1"/>
          <p:nvPr/>
        </p:nvSpPr>
        <p:spPr>
          <a:xfrm>
            <a:off x="526173" y="444351"/>
            <a:ext cx="2677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93B86D2-1666-9549-2F7E-41448F8DFC7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2" t="2595" r="-1" b="58152"/>
          <a:stretch/>
        </p:blipFill>
        <p:spPr bwMode="auto">
          <a:xfrm>
            <a:off x="2473539" y="3429000"/>
            <a:ext cx="6676176" cy="181102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3C96F9D-CB0A-A17F-6F7D-4733C7CA2678}"/>
              </a:ext>
            </a:extLst>
          </p:cNvPr>
          <p:cNvSpPr txBox="1"/>
          <p:nvPr/>
        </p:nvSpPr>
        <p:spPr>
          <a:xfrm>
            <a:off x="2619375" y="5307568"/>
            <a:ext cx="131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0BAAF43-587B-44E3-F6D3-2E500AA9A3F3}"/>
              </a:ext>
            </a:extLst>
          </p:cNvPr>
          <p:cNvSpPr txBox="1"/>
          <p:nvPr/>
        </p:nvSpPr>
        <p:spPr>
          <a:xfrm>
            <a:off x="4400550" y="5307568"/>
            <a:ext cx="131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Gal 40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7F3B592-9E03-E118-C061-1E4BED3BD86F}"/>
              </a:ext>
            </a:extLst>
          </p:cNvPr>
          <p:cNvSpPr txBox="1"/>
          <p:nvPr/>
        </p:nvSpPr>
        <p:spPr>
          <a:xfrm>
            <a:off x="6181725" y="5255379"/>
            <a:ext cx="131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Gal 50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0FA4C48-6AAA-5BF7-F0B5-7C328DEF13D1}"/>
              </a:ext>
            </a:extLst>
          </p:cNvPr>
          <p:cNvSpPr txBox="1"/>
          <p:nvPr/>
        </p:nvSpPr>
        <p:spPr>
          <a:xfrm>
            <a:off x="7962900" y="5299313"/>
            <a:ext cx="131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Gal 60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BD6DB5E-78AF-A048-4135-FC7A5F1BAAEA}"/>
              </a:ext>
            </a:extLst>
          </p:cNvPr>
          <p:cNvSpPr txBox="1"/>
          <p:nvPr/>
        </p:nvSpPr>
        <p:spPr>
          <a:xfrm>
            <a:off x="1207923" y="4149844"/>
            <a:ext cx="131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042B3ABE-95A5-455C-2967-A6B573EB57D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8" t="3455" r="150" b="18058"/>
          <a:stretch/>
        </p:blipFill>
        <p:spPr bwMode="auto">
          <a:xfrm>
            <a:off x="2404144" y="1331575"/>
            <a:ext cx="6676176" cy="152629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6F460B3A-200B-1946-954D-742F02B0F3F5}"/>
              </a:ext>
            </a:extLst>
          </p:cNvPr>
          <p:cNvSpPr txBox="1"/>
          <p:nvPr/>
        </p:nvSpPr>
        <p:spPr>
          <a:xfrm>
            <a:off x="2413669" y="2867323"/>
            <a:ext cx="131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339FC96-8631-A40F-484A-2CEE2F482ADE}"/>
              </a:ext>
            </a:extLst>
          </p:cNvPr>
          <p:cNvSpPr txBox="1"/>
          <p:nvPr/>
        </p:nvSpPr>
        <p:spPr>
          <a:xfrm>
            <a:off x="4194844" y="2867323"/>
            <a:ext cx="131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Gal 40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F0674CA-C840-4982-8783-453E13A869CB}"/>
              </a:ext>
            </a:extLst>
          </p:cNvPr>
          <p:cNvSpPr txBox="1"/>
          <p:nvPr/>
        </p:nvSpPr>
        <p:spPr>
          <a:xfrm>
            <a:off x="5976019" y="2815134"/>
            <a:ext cx="131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Gal 50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9B11174-C845-C00D-D138-E59A2E8EF78F}"/>
              </a:ext>
            </a:extLst>
          </p:cNvPr>
          <p:cNvSpPr txBox="1"/>
          <p:nvPr/>
        </p:nvSpPr>
        <p:spPr>
          <a:xfrm>
            <a:off x="7757194" y="2859068"/>
            <a:ext cx="131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Gal 60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DF9E525-2358-7A11-C321-55CC4EA1DA77}"/>
              </a:ext>
            </a:extLst>
          </p:cNvPr>
          <p:cNvSpPr txBox="1"/>
          <p:nvPr/>
        </p:nvSpPr>
        <p:spPr>
          <a:xfrm>
            <a:off x="1089694" y="1927765"/>
            <a:ext cx="131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FCFB455-AAE8-1AD7-C91E-32A370C16250}"/>
              </a:ext>
            </a:extLst>
          </p:cNvPr>
          <p:cNvSpPr txBox="1"/>
          <p:nvPr/>
        </p:nvSpPr>
        <p:spPr>
          <a:xfrm>
            <a:off x="2619375" y="5890822"/>
            <a:ext cx="667617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ea typeface="Calibri" panose="020F0502020204030204" pitchFamily="34" charset="0"/>
              </a:rPr>
              <a:t>Supp. Fig. 1: 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orphological changes in a) liver and b) </a:t>
            </a:r>
            <a:r>
              <a:rPr lang="en-IN" dirty="0">
                <a:latin typeface="Times New Roman" panose="02020603050405020304" pitchFamily="18" charset="0"/>
                <a:ea typeface="Calibri" panose="020F0502020204030204" pitchFamily="34" charset="0"/>
              </a:rPr>
              <a:t>kidney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due to D-Gal administration. 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7315456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0A2000B-06A0-FA9D-F374-79A028B7C8AD}"/>
              </a:ext>
            </a:extLst>
          </p:cNvPr>
          <p:cNvSpPr txBox="1"/>
          <p:nvPr/>
        </p:nvSpPr>
        <p:spPr>
          <a:xfrm>
            <a:off x="126123" y="72876"/>
            <a:ext cx="2677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614E31D-C0A4-11FA-8E95-BC894346166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2853" b="14995"/>
          <a:stretch>
            <a:fillRect/>
          </a:stretch>
        </p:blipFill>
        <p:spPr>
          <a:xfrm>
            <a:off x="933451" y="340342"/>
            <a:ext cx="4438650" cy="306942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59BEB63-F67D-E6B9-4B27-DCD1D44EE3F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2853" b="12108"/>
          <a:stretch>
            <a:fillRect/>
          </a:stretch>
        </p:blipFill>
        <p:spPr>
          <a:xfrm>
            <a:off x="6268864" y="359577"/>
            <a:ext cx="4292813" cy="306942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B471702-9B8D-F9D5-E8EA-10D489B8C0B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3432" b="16499"/>
          <a:stretch>
            <a:fillRect/>
          </a:stretch>
        </p:blipFill>
        <p:spPr>
          <a:xfrm>
            <a:off x="852570" y="3174165"/>
            <a:ext cx="4653495" cy="318221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AB76FA7-2F94-6E43-7769-F20A61732D10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3432" t="5379" b="16499"/>
          <a:stretch>
            <a:fillRect/>
          </a:stretch>
        </p:blipFill>
        <p:spPr>
          <a:xfrm>
            <a:off x="6364603" y="3429000"/>
            <a:ext cx="4419064" cy="282721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2B14906-B636-408B-AA2F-ADAE3CCAD8DB}"/>
              </a:ext>
            </a:extLst>
          </p:cNvPr>
          <p:cNvSpPr txBox="1"/>
          <p:nvPr/>
        </p:nvSpPr>
        <p:spPr>
          <a:xfrm>
            <a:off x="138648" y="301871"/>
            <a:ext cx="1326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1376C05-E0F0-A07D-9EB2-61DBE7B476FA}"/>
              </a:ext>
            </a:extLst>
          </p:cNvPr>
          <p:cNvSpPr txBox="1"/>
          <p:nvPr/>
        </p:nvSpPr>
        <p:spPr>
          <a:xfrm>
            <a:off x="6046874" y="442208"/>
            <a:ext cx="1326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D97940C-E965-BC5E-93DE-B77F8E6A0172}"/>
              </a:ext>
            </a:extLst>
          </p:cNvPr>
          <p:cNvSpPr txBox="1"/>
          <p:nvPr/>
        </p:nvSpPr>
        <p:spPr>
          <a:xfrm>
            <a:off x="138648" y="3307899"/>
            <a:ext cx="1326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11E3916-BA77-9F1D-02BD-11DB52075BED}"/>
              </a:ext>
            </a:extLst>
          </p:cNvPr>
          <p:cNvSpPr txBox="1"/>
          <p:nvPr/>
        </p:nvSpPr>
        <p:spPr>
          <a:xfrm>
            <a:off x="6022712" y="3307899"/>
            <a:ext cx="1326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4D0B0A2-BB66-E356-8223-598FBE4EA5BB}"/>
              </a:ext>
            </a:extLst>
          </p:cNvPr>
          <p:cNvSpPr txBox="1"/>
          <p:nvPr/>
        </p:nvSpPr>
        <p:spPr>
          <a:xfrm>
            <a:off x="353961" y="6222964"/>
            <a:ext cx="1183803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ea typeface="Calibri" panose="020F0502020204030204" pitchFamily="34" charset="0"/>
              </a:rPr>
              <a:t>Supp. Fig. 2: correlation analysis of liver tissue A) D-Gal 400, B) D-Gal 600. Correlation analysis of kidney tissue C) D-Gal 400, E) D-Gal 600.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endParaRPr lang="en-IN" dirty="0"/>
          </a:p>
        </p:txBody>
      </p:sp>
      <p:sp>
        <p:nvSpPr>
          <p:cNvPr id="5" name="TextBox 15">
            <a:extLst>
              <a:ext uri="{FF2B5EF4-FFF2-40B4-BE49-F238E27FC236}">
                <a16:creationId xmlns:a16="http://schemas.microsoft.com/office/drawing/2014/main" id="{2CBD2D9A-7942-7339-B994-E1982A1EC469}"/>
              </a:ext>
            </a:extLst>
          </p:cNvPr>
          <p:cNvSpPr txBox="1"/>
          <p:nvPr/>
        </p:nvSpPr>
        <p:spPr>
          <a:xfrm>
            <a:off x="4333315" y="319097"/>
            <a:ext cx="15541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coefficient (r)</a:t>
            </a:r>
          </a:p>
        </p:txBody>
      </p:sp>
      <p:sp>
        <p:nvSpPr>
          <p:cNvPr id="12" name="TextBox 15">
            <a:extLst>
              <a:ext uri="{FF2B5EF4-FFF2-40B4-BE49-F238E27FC236}">
                <a16:creationId xmlns:a16="http://schemas.microsoft.com/office/drawing/2014/main" id="{7E2A0CC6-DD56-6D6D-AFFB-D83F5D5E06AE}"/>
              </a:ext>
            </a:extLst>
          </p:cNvPr>
          <p:cNvSpPr txBox="1"/>
          <p:nvPr/>
        </p:nvSpPr>
        <p:spPr>
          <a:xfrm>
            <a:off x="9388928" y="363426"/>
            <a:ext cx="15541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coefficient (r)</a:t>
            </a:r>
          </a:p>
        </p:txBody>
      </p:sp>
      <p:sp>
        <p:nvSpPr>
          <p:cNvPr id="14" name="TextBox 15">
            <a:extLst>
              <a:ext uri="{FF2B5EF4-FFF2-40B4-BE49-F238E27FC236}">
                <a16:creationId xmlns:a16="http://schemas.microsoft.com/office/drawing/2014/main" id="{9C7B45FE-CEE3-9148-CE19-23B2D496A5C0}"/>
              </a:ext>
            </a:extLst>
          </p:cNvPr>
          <p:cNvSpPr txBox="1"/>
          <p:nvPr/>
        </p:nvSpPr>
        <p:spPr>
          <a:xfrm>
            <a:off x="4492725" y="3212301"/>
            <a:ext cx="15541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coefficient (r)</a:t>
            </a:r>
          </a:p>
        </p:txBody>
      </p:sp>
      <p:sp>
        <p:nvSpPr>
          <p:cNvPr id="15" name="TextBox 15">
            <a:extLst>
              <a:ext uri="{FF2B5EF4-FFF2-40B4-BE49-F238E27FC236}">
                <a16:creationId xmlns:a16="http://schemas.microsoft.com/office/drawing/2014/main" id="{6ADC0C24-C04C-466B-2335-8D7B5440A233}"/>
              </a:ext>
            </a:extLst>
          </p:cNvPr>
          <p:cNvSpPr txBox="1"/>
          <p:nvPr/>
        </p:nvSpPr>
        <p:spPr>
          <a:xfrm>
            <a:off x="9770327" y="3193647"/>
            <a:ext cx="15541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coefficient (r)</a:t>
            </a:r>
          </a:p>
        </p:txBody>
      </p:sp>
    </p:spTree>
    <p:extLst>
      <p:ext uri="{BB962C8B-B14F-4D97-AF65-F5344CB8AC3E}">
        <p14:creationId xmlns:p14="http://schemas.microsoft.com/office/powerpoint/2010/main" val="3944487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13</Words>
  <Application>Microsoft Office PowerPoint</Application>
  <PresentationFormat>Widescreen</PresentationFormat>
  <Paragraphs>2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ILIMA BANGAR</dc:creator>
  <cp:lastModifiedBy>NILIMA BANGAR</cp:lastModifiedBy>
  <cp:revision>1</cp:revision>
  <dcterms:created xsi:type="dcterms:W3CDTF">2025-07-09T04:32:31Z</dcterms:created>
  <dcterms:modified xsi:type="dcterms:W3CDTF">2025-07-17T18:08:07Z</dcterms:modified>
</cp:coreProperties>
</file>